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48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6350" y="146050"/>
            <a:ext cx="9156700" cy="6565900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6350" y="146050"/>
            <a:ext cx="9156700" cy="6330950"/>
          </a:xfrm>
          <a:prstGeom prst="rect">
            <a:avLst/>
          </a:prstGeom>
          <a:noFill/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0" y="6400800"/>
            <a:ext cx="8915400" cy="43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1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The relative expression values of </a:t>
            </a:r>
            <a:r>
              <a:rPr kumimoji="0" lang="en-US" sz="11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bPRPs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in roots, stems and leaf tissues under drought, salt, heat and cold stress. Error bars indicate ± SD. </a:t>
            </a:r>
            <a:r>
              <a:rPr kumimoji="0" lang="en-US" sz="11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ndicate significant differences calculated by t-test (</a:t>
            </a:r>
            <a:r>
              <a:rPr kumimoji="0" lang="en-US" sz="11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*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 ≤ 0.05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On-screen Show (4:3)</PresentationFormat>
  <Paragraphs>1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2</cp:revision>
  <dcterms:created xsi:type="dcterms:W3CDTF">2006-08-16T00:00:00Z</dcterms:created>
  <dcterms:modified xsi:type="dcterms:W3CDTF">2022-08-06T07:02:53Z</dcterms:modified>
</cp:coreProperties>
</file>